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6" r:id="rId2"/>
    <p:sldId id="285" r:id="rId3"/>
    <p:sldId id="280" r:id="rId4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7D7D"/>
    <a:srgbClr val="5F5F5F"/>
    <a:srgbClr val="777777"/>
    <a:srgbClr val="C0C0C0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5226" autoAdjust="0"/>
  </p:normalViewPr>
  <p:slideViewPr>
    <p:cSldViewPr snapToGrid="0">
      <p:cViewPr varScale="1">
        <p:scale>
          <a:sx n="78" d="100"/>
          <a:sy n="78" d="100"/>
        </p:scale>
        <p:origin x="80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Prof.%20Amoresano%20Angela\Tea%20polifenoli\Paper%20manuscript\Histograms%20for%20paper%20the%20last%20010520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Prof.%20Amoresano%20Angela\Tea%20polifenoli\Paper%20manuscript\Suppl%20material\Supplementary%20Table%203%20heavy%20metal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Prof.%20Amoresano%20Angela\Tea%20polifenoli\Paper%20manuscript\Suppl%20material\Heavy%20metals%20processin%20dat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767206607925467"/>
          <c:y val="2.7659039476992709E-2"/>
          <c:w val="0.84117513023824175"/>
          <c:h val="0.6438371695418896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verage areas_paper'!$B$3</c:f>
              <c:strCache>
                <c:ptCount val="1"/>
                <c:pt idx="0">
                  <c:v> Black tea</c:v>
                </c:pt>
              </c:strCache>
            </c:strRef>
          </c:tx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verage areas_paper'!$A$27:$A$41</c:f>
              <c:strCache>
                <c:ptCount val="15"/>
                <c:pt idx="0">
                  <c:v>Rutin</c:v>
                </c:pt>
                <c:pt idx="1">
                  <c:v>Kaempeferol-3-O-Rhamnoside</c:v>
                </c:pt>
                <c:pt idx="2">
                  <c:v>Quercetin-O-Rhamnoside</c:v>
                </c:pt>
                <c:pt idx="3">
                  <c:v>Quercetin-3-O-galactoside</c:v>
                </c:pt>
                <c:pt idx="4">
                  <c:v>kaempferol-3-O-rutinoside</c:v>
                </c:pt>
                <c:pt idx="5">
                  <c:v>Nicotinflorin</c:v>
                </c:pt>
                <c:pt idx="6">
                  <c:v>Apigenin-8-c-glucoside </c:v>
                </c:pt>
                <c:pt idx="7">
                  <c:v>Quercetin rutinoside</c:v>
                </c:pt>
                <c:pt idx="8">
                  <c:v>Astragalin</c:v>
                </c:pt>
                <c:pt idx="9">
                  <c:v>Orientin</c:v>
                </c:pt>
                <c:pt idx="10">
                  <c:v>Luteolin-7-O-Glucoside</c:v>
                </c:pt>
                <c:pt idx="11">
                  <c:v>Naringin</c:v>
                </c:pt>
                <c:pt idx="12">
                  <c:v>Myricetin-3-O-glucoside</c:v>
                </c:pt>
                <c:pt idx="13">
                  <c:v>Luteolin-6-c-glucoside </c:v>
                </c:pt>
                <c:pt idx="14">
                  <c:v>Quercetin acetylhexoside</c:v>
                </c:pt>
              </c:strCache>
            </c:strRef>
          </c:cat>
          <c:val>
            <c:numRef>
              <c:f>'Average areas_paper'!$B$27:$B$41</c:f>
              <c:numCache>
                <c:formatCode>0.00E+00</c:formatCode>
                <c:ptCount val="15"/>
                <c:pt idx="0">
                  <c:v>435702.54097079998</c:v>
                </c:pt>
                <c:pt idx="1">
                  <c:v>3267.7750962</c:v>
                </c:pt>
                <c:pt idx="2">
                  <c:v>300206.12194619997</c:v>
                </c:pt>
                <c:pt idx="3">
                  <c:v>81855.574033500001</c:v>
                </c:pt>
                <c:pt idx="4">
                  <c:v>60511.460596199999</c:v>
                </c:pt>
                <c:pt idx="5">
                  <c:v>45413.236096200002</c:v>
                </c:pt>
                <c:pt idx="6">
                  <c:v>37594.191346200001</c:v>
                </c:pt>
                <c:pt idx="7">
                  <c:v>34644.728896200002</c:v>
                </c:pt>
                <c:pt idx="8">
                  <c:v>24390.8929962</c:v>
                </c:pt>
                <c:pt idx="9">
                  <c:v>21978.287641874998</c:v>
                </c:pt>
                <c:pt idx="10">
                  <c:v>11819.2366962</c:v>
                </c:pt>
                <c:pt idx="11">
                  <c:v>9518.4870885</c:v>
                </c:pt>
                <c:pt idx="12">
                  <c:v>6045.5218293750004</c:v>
                </c:pt>
                <c:pt idx="13">
                  <c:v>2344.490601</c:v>
                </c:pt>
                <c:pt idx="14">
                  <c:v>1163.5359135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84-47F8-B614-8D3DD2BEFFE0}"/>
            </c:ext>
          </c:extLst>
        </c:ser>
        <c:ser>
          <c:idx val="1"/>
          <c:order val="1"/>
          <c:tx>
            <c:strRef>
              <c:f>'Average areas_paper'!$C$3</c:f>
              <c:strCache>
                <c:ptCount val="1"/>
                <c:pt idx="0">
                  <c:v>Blue Tea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verage areas_paper'!$A$27:$A$41</c:f>
              <c:strCache>
                <c:ptCount val="15"/>
                <c:pt idx="0">
                  <c:v>Rutin</c:v>
                </c:pt>
                <c:pt idx="1">
                  <c:v>Kaempeferol-3-O-Rhamnoside</c:v>
                </c:pt>
                <c:pt idx="2">
                  <c:v>Quercetin-O-Rhamnoside</c:v>
                </c:pt>
                <c:pt idx="3">
                  <c:v>Quercetin-3-O-galactoside</c:v>
                </c:pt>
                <c:pt idx="4">
                  <c:v>kaempferol-3-O-rutinoside</c:v>
                </c:pt>
                <c:pt idx="5">
                  <c:v>Nicotinflorin</c:v>
                </c:pt>
                <c:pt idx="6">
                  <c:v>Apigenin-8-c-glucoside </c:v>
                </c:pt>
                <c:pt idx="7">
                  <c:v>Quercetin rutinoside</c:v>
                </c:pt>
                <c:pt idx="8">
                  <c:v>Astragalin</c:v>
                </c:pt>
                <c:pt idx="9">
                  <c:v>Orientin</c:v>
                </c:pt>
                <c:pt idx="10">
                  <c:v>Luteolin-7-O-Glucoside</c:v>
                </c:pt>
                <c:pt idx="11">
                  <c:v>Naringin</c:v>
                </c:pt>
                <c:pt idx="12">
                  <c:v>Myricetin-3-O-glucoside</c:v>
                </c:pt>
                <c:pt idx="13">
                  <c:v>Luteolin-6-c-glucoside </c:v>
                </c:pt>
                <c:pt idx="14">
                  <c:v>Quercetin acetylhexoside</c:v>
                </c:pt>
              </c:strCache>
            </c:strRef>
          </c:cat>
          <c:val>
            <c:numRef>
              <c:f>'Average areas_paper'!$C$27:$C$41</c:f>
              <c:numCache>
                <c:formatCode>0.00E+00</c:formatCode>
                <c:ptCount val="15"/>
                <c:pt idx="0">
                  <c:v>243922.6203135</c:v>
                </c:pt>
                <c:pt idx="1">
                  <c:v>0</c:v>
                </c:pt>
                <c:pt idx="2">
                  <c:v>4951.3780635000003</c:v>
                </c:pt>
                <c:pt idx="3">
                  <c:v>29956.125313500001</c:v>
                </c:pt>
                <c:pt idx="4">
                  <c:v>8919.3858134999991</c:v>
                </c:pt>
                <c:pt idx="5">
                  <c:v>10700.940313499999</c:v>
                </c:pt>
                <c:pt idx="6">
                  <c:v>1080.5999999999999</c:v>
                </c:pt>
                <c:pt idx="7">
                  <c:v>4960.3758134999998</c:v>
                </c:pt>
                <c:pt idx="8">
                  <c:v>5905.1395634999999</c:v>
                </c:pt>
                <c:pt idx="9">
                  <c:v>7137.8313134999999</c:v>
                </c:pt>
                <c:pt idx="10">
                  <c:v>2935.8820635000002</c:v>
                </c:pt>
                <c:pt idx="11">
                  <c:v>3502.7403135</c:v>
                </c:pt>
                <c:pt idx="12">
                  <c:v>17089.342813499999</c:v>
                </c:pt>
                <c:pt idx="13">
                  <c:v>0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84-47F8-B614-8D3DD2BEFFE0}"/>
            </c:ext>
          </c:extLst>
        </c:ser>
        <c:ser>
          <c:idx val="2"/>
          <c:order val="2"/>
          <c:tx>
            <c:strRef>
              <c:f>'Average areas_paper'!$D$3</c:f>
              <c:strCache>
                <c:ptCount val="1"/>
                <c:pt idx="0">
                  <c:v>Green tea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verage areas_paper'!$A$27:$A$41</c:f>
              <c:strCache>
                <c:ptCount val="15"/>
                <c:pt idx="0">
                  <c:v>Rutin</c:v>
                </c:pt>
                <c:pt idx="1">
                  <c:v>Kaempeferol-3-O-Rhamnoside</c:v>
                </c:pt>
                <c:pt idx="2">
                  <c:v>Quercetin-O-Rhamnoside</c:v>
                </c:pt>
                <c:pt idx="3">
                  <c:v>Quercetin-3-O-galactoside</c:v>
                </c:pt>
                <c:pt idx="4">
                  <c:v>kaempferol-3-O-rutinoside</c:v>
                </c:pt>
                <c:pt idx="5">
                  <c:v>Nicotinflorin</c:v>
                </c:pt>
                <c:pt idx="6">
                  <c:v>Apigenin-8-c-glucoside </c:v>
                </c:pt>
                <c:pt idx="7">
                  <c:v>Quercetin rutinoside</c:v>
                </c:pt>
                <c:pt idx="8">
                  <c:v>Astragalin</c:v>
                </c:pt>
                <c:pt idx="9">
                  <c:v>Orientin</c:v>
                </c:pt>
                <c:pt idx="10">
                  <c:v>Luteolin-7-O-Glucoside</c:v>
                </c:pt>
                <c:pt idx="11">
                  <c:v>Naringin</c:v>
                </c:pt>
                <c:pt idx="12">
                  <c:v>Myricetin-3-O-glucoside</c:v>
                </c:pt>
                <c:pt idx="13">
                  <c:v>Luteolin-6-c-glucoside </c:v>
                </c:pt>
                <c:pt idx="14">
                  <c:v>Quercetin acetylhexoside</c:v>
                </c:pt>
              </c:strCache>
            </c:strRef>
          </c:cat>
          <c:val>
            <c:numRef>
              <c:f>'Average areas_paper'!$D$27:$D$41</c:f>
              <c:numCache>
                <c:formatCode>0.00E+00</c:formatCode>
                <c:ptCount val="15"/>
                <c:pt idx="0">
                  <c:v>186157.27591349999</c:v>
                </c:pt>
                <c:pt idx="1">
                  <c:v>122403.71828849999</c:v>
                </c:pt>
                <c:pt idx="2">
                  <c:v>74315.243413499993</c:v>
                </c:pt>
                <c:pt idx="3">
                  <c:v>59064.0571634999</c:v>
                </c:pt>
                <c:pt idx="4">
                  <c:v>25502.4496635</c:v>
                </c:pt>
                <c:pt idx="5">
                  <c:v>18304.249663499999</c:v>
                </c:pt>
                <c:pt idx="6">
                  <c:v>11596.4270385</c:v>
                </c:pt>
                <c:pt idx="7">
                  <c:v>0</c:v>
                </c:pt>
                <c:pt idx="8">
                  <c:v>32520.694663499999</c:v>
                </c:pt>
                <c:pt idx="9">
                  <c:v>37199.5246635</c:v>
                </c:pt>
                <c:pt idx="10">
                  <c:v>15510.4482885</c:v>
                </c:pt>
                <c:pt idx="11">
                  <c:v>3201.5262885000002</c:v>
                </c:pt>
                <c:pt idx="12">
                  <c:v>16864.609663499999</c:v>
                </c:pt>
                <c:pt idx="13">
                  <c:v>3044.0656635</c:v>
                </c:pt>
                <c:pt idx="1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384-47F8-B614-8D3DD2BEFF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134378479"/>
        <c:axId val="1259706431"/>
      </c:barChart>
      <c:catAx>
        <c:axId val="113437847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259706431"/>
        <c:crosses val="autoZero"/>
        <c:auto val="1"/>
        <c:lblAlgn val="ctr"/>
        <c:lblOffset val="100"/>
        <c:noMultiLvlLbl val="0"/>
      </c:catAx>
      <c:valAx>
        <c:axId val="1259706431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it-IT" sz="1600" b="1"/>
                  <a:t>EIC peak area</a:t>
                </a:r>
              </a:p>
            </c:rich>
          </c:tx>
          <c:layout>
            <c:manualLayout>
              <c:xMode val="edge"/>
              <c:yMode val="edge"/>
              <c:x val="4.6312258304989981E-4"/>
              <c:y val="0.2063876473137466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@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1343784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7957834226838668"/>
          <c:y val="0.20710103006631067"/>
          <c:w val="0.71844760428882559"/>
          <c:h val="8.301442085926309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800" b="1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943996415770611"/>
          <c:y val="4.4311413128153503E-2"/>
          <c:w val="0.84652777777777777"/>
          <c:h val="0.8542248190820689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nal table heavy metal'!$B$6</c:f>
              <c:strCache>
                <c:ptCount val="1"/>
                <c:pt idx="0">
                  <c:v>BT Leave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1:$A$25</c:f>
              <c:strCache>
                <c:ptCount val="5"/>
                <c:pt idx="0">
                  <c:v>Ni</c:v>
                </c:pt>
                <c:pt idx="1">
                  <c:v>Cr</c:v>
                </c:pt>
                <c:pt idx="2">
                  <c:v>Ti</c:v>
                </c:pt>
                <c:pt idx="3">
                  <c:v>Pb</c:v>
                </c:pt>
                <c:pt idx="4">
                  <c:v>Cs</c:v>
                </c:pt>
              </c:strCache>
            </c:strRef>
          </c:cat>
          <c:val>
            <c:numRef>
              <c:f>'Final table heavy metal'!$B$21:$B$25</c:f>
              <c:numCache>
                <c:formatCode>0.000</c:formatCode>
                <c:ptCount val="5"/>
                <c:pt idx="0">
                  <c:v>4.3809999999999993</c:v>
                </c:pt>
                <c:pt idx="1">
                  <c:v>3.9780000000000002</c:v>
                </c:pt>
                <c:pt idx="2">
                  <c:v>2.1245000000000003</c:v>
                </c:pt>
                <c:pt idx="3">
                  <c:v>0.28116666666666673</c:v>
                </c:pt>
                <c:pt idx="4">
                  <c:v>0.219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AF9-4C87-9E62-6495FE1BDD0F}"/>
            </c:ext>
          </c:extLst>
        </c:ser>
        <c:ser>
          <c:idx val="1"/>
          <c:order val="1"/>
          <c:tx>
            <c:strRef>
              <c:f>'Final table heavy metal'!$C$6</c:f>
              <c:strCache>
                <c:ptCount val="1"/>
                <c:pt idx="0">
                  <c:v>BT infusion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1:$A$25</c:f>
              <c:strCache>
                <c:ptCount val="5"/>
                <c:pt idx="0">
                  <c:v>Ni</c:v>
                </c:pt>
                <c:pt idx="1">
                  <c:v>Cr</c:v>
                </c:pt>
                <c:pt idx="2">
                  <c:v>Ti</c:v>
                </c:pt>
                <c:pt idx="3">
                  <c:v>Pb</c:v>
                </c:pt>
                <c:pt idx="4">
                  <c:v>Cs</c:v>
                </c:pt>
              </c:strCache>
            </c:strRef>
          </c:cat>
          <c:val>
            <c:numRef>
              <c:f>'Final table heavy metal'!$C$21:$C$25</c:f>
              <c:numCache>
                <c:formatCode>0.000</c:formatCode>
                <c:ptCount val="5"/>
                <c:pt idx="0">
                  <c:v>1.5773333333333335</c:v>
                </c:pt>
                <c:pt idx="1">
                  <c:v>0</c:v>
                </c:pt>
                <c:pt idx="2">
                  <c:v>0.20116666666666663</c:v>
                </c:pt>
                <c:pt idx="3">
                  <c:v>6.9400000000000003E-2</c:v>
                </c:pt>
                <c:pt idx="4">
                  <c:v>0.2025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AF9-4C87-9E62-6495FE1BDD0F}"/>
            </c:ext>
          </c:extLst>
        </c:ser>
        <c:ser>
          <c:idx val="2"/>
          <c:order val="2"/>
          <c:tx>
            <c:strRef>
              <c:f>'Final table heavy metal'!$D$6</c:f>
              <c:strCache>
                <c:ptCount val="1"/>
                <c:pt idx="0">
                  <c:v>OT Leaves 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1:$A$25</c:f>
              <c:strCache>
                <c:ptCount val="5"/>
                <c:pt idx="0">
                  <c:v>Ni</c:v>
                </c:pt>
                <c:pt idx="1">
                  <c:v>Cr</c:v>
                </c:pt>
                <c:pt idx="2">
                  <c:v>Ti</c:v>
                </c:pt>
                <c:pt idx="3">
                  <c:v>Pb</c:v>
                </c:pt>
                <c:pt idx="4">
                  <c:v>Cs</c:v>
                </c:pt>
              </c:strCache>
            </c:strRef>
          </c:cat>
          <c:val>
            <c:numRef>
              <c:f>'Final table heavy metal'!$D$21:$D$25</c:f>
              <c:numCache>
                <c:formatCode>0.000</c:formatCode>
                <c:ptCount val="5"/>
                <c:pt idx="0">
                  <c:v>0.88100000000000001</c:v>
                </c:pt>
                <c:pt idx="1">
                  <c:v>0.48699999999999999</c:v>
                </c:pt>
                <c:pt idx="2">
                  <c:v>0.503</c:v>
                </c:pt>
                <c:pt idx="3">
                  <c:v>0.13800000000000001</c:v>
                </c:pt>
                <c:pt idx="4">
                  <c:v>3.500000000000000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AF9-4C87-9E62-6495FE1BDD0F}"/>
            </c:ext>
          </c:extLst>
        </c:ser>
        <c:ser>
          <c:idx val="3"/>
          <c:order val="3"/>
          <c:tx>
            <c:strRef>
              <c:f>'Final table heavy metal'!$E$6</c:f>
              <c:strCache>
                <c:ptCount val="1"/>
                <c:pt idx="0">
                  <c:v>OT tea </c:v>
                </c:pt>
              </c:strCache>
            </c:strRef>
          </c:tx>
          <c:spPr>
            <a:solidFill>
              <a:srgbClr val="FF7D7D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1:$A$25</c:f>
              <c:strCache>
                <c:ptCount val="5"/>
                <c:pt idx="0">
                  <c:v>Ni</c:v>
                </c:pt>
                <c:pt idx="1">
                  <c:v>Cr</c:v>
                </c:pt>
                <c:pt idx="2">
                  <c:v>Ti</c:v>
                </c:pt>
                <c:pt idx="3">
                  <c:v>Pb</c:v>
                </c:pt>
                <c:pt idx="4">
                  <c:v>Cs</c:v>
                </c:pt>
              </c:strCache>
            </c:strRef>
          </c:cat>
          <c:val>
            <c:numRef>
              <c:f>'Final table heavy metal'!$E$21:$E$25</c:f>
              <c:numCache>
                <c:formatCode>0.000</c:formatCode>
                <c:ptCount val="5"/>
                <c:pt idx="0">
                  <c:v>0.46700000000000003</c:v>
                </c:pt>
                <c:pt idx="1">
                  <c:v>0</c:v>
                </c:pt>
                <c:pt idx="2">
                  <c:v>3.3000000000000002E-2</c:v>
                </c:pt>
                <c:pt idx="3">
                  <c:v>8.9999999999999993E-3</c:v>
                </c:pt>
                <c:pt idx="4">
                  <c:v>0.1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AF9-4C87-9E62-6495FE1BDD0F}"/>
            </c:ext>
          </c:extLst>
        </c:ser>
        <c:ser>
          <c:idx val="4"/>
          <c:order val="4"/>
          <c:tx>
            <c:strRef>
              <c:f>'Final table heavy metal'!$F$6</c:f>
              <c:strCache>
                <c:ptCount val="1"/>
                <c:pt idx="0">
                  <c:v>GT Leav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1:$A$25</c:f>
              <c:strCache>
                <c:ptCount val="5"/>
                <c:pt idx="0">
                  <c:v>Ni</c:v>
                </c:pt>
                <c:pt idx="1">
                  <c:v>Cr</c:v>
                </c:pt>
                <c:pt idx="2">
                  <c:v>Ti</c:v>
                </c:pt>
                <c:pt idx="3">
                  <c:v>Pb</c:v>
                </c:pt>
                <c:pt idx="4">
                  <c:v>Cs</c:v>
                </c:pt>
              </c:strCache>
            </c:strRef>
          </c:cat>
          <c:val>
            <c:numRef>
              <c:f>'Final table heavy metal'!$F$21:$F$25</c:f>
              <c:numCache>
                <c:formatCode>0.000</c:formatCode>
                <c:ptCount val="5"/>
                <c:pt idx="0">
                  <c:v>8.8934999999999995</c:v>
                </c:pt>
                <c:pt idx="1">
                  <c:v>0.83299999999999996</c:v>
                </c:pt>
                <c:pt idx="2">
                  <c:v>1.518</c:v>
                </c:pt>
                <c:pt idx="3">
                  <c:v>0.67849999999999999</c:v>
                </c:pt>
                <c:pt idx="4">
                  <c:v>7.0500000000000007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AF9-4C87-9E62-6495FE1BDD0F}"/>
            </c:ext>
          </c:extLst>
        </c:ser>
        <c:ser>
          <c:idx val="5"/>
          <c:order val="5"/>
          <c:tx>
            <c:strRef>
              <c:f>'Final table heavy metal'!$G$6</c:f>
              <c:strCache>
                <c:ptCount val="1"/>
                <c:pt idx="0">
                  <c:v>GT infusion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1:$A$25</c:f>
              <c:strCache>
                <c:ptCount val="5"/>
                <c:pt idx="0">
                  <c:v>Ni</c:v>
                </c:pt>
                <c:pt idx="1">
                  <c:v>Cr</c:v>
                </c:pt>
                <c:pt idx="2">
                  <c:v>Ti</c:v>
                </c:pt>
                <c:pt idx="3">
                  <c:v>Pb</c:v>
                </c:pt>
                <c:pt idx="4">
                  <c:v>Cs</c:v>
                </c:pt>
              </c:strCache>
            </c:strRef>
          </c:cat>
          <c:val>
            <c:numRef>
              <c:f>'Final table heavy metal'!$G$21:$G$25</c:f>
              <c:numCache>
                <c:formatCode>0.000</c:formatCode>
                <c:ptCount val="5"/>
                <c:pt idx="0">
                  <c:v>11.8</c:v>
                </c:pt>
                <c:pt idx="1">
                  <c:v>0</c:v>
                </c:pt>
                <c:pt idx="2">
                  <c:v>9.7000000000000003E-2</c:v>
                </c:pt>
                <c:pt idx="3">
                  <c:v>2.7E-2</c:v>
                </c:pt>
                <c:pt idx="4">
                  <c:v>8.7999999999999995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AF9-4C87-9E62-6495FE1BDD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33725392"/>
        <c:axId val="1033714512"/>
      </c:barChart>
      <c:catAx>
        <c:axId val="103372539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33714512"/>
        <c:crosses val="autoZero"/>
        <c:auto val="1"/>
        <c:lblAlgn val="ctr"/>
        <c:lblOffset val="100"/>
        <c:noMultiLvlLbl val="0"/>
      </c:catAx>
      <c:valAx>
        <c:axId val="103371451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it-IT" sz="1400" b="1">
                    <a:solidFill>
                      <a:schemeClr val="tx1"/>
                    </a:solidFill>
                  </a:rPr>
                  <a:t>µg/g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,000" sourceLinked="0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0337253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it-IT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nal table heavy metal'!$B$6</c:f>
              <c:strCache>
                <c:ptCount val="1"/>
                <c:pt idx="0">
                  <c:v>BT Leaves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7:$A$36</c:f>
              <c:strCache>
                <c:ptCount val="10"/>
                <c:pt idx="0">
                  <c:v>V</c:v>
                </c:pt>
                <c:pt idx="1">
                  <c:v>Co</c:v>
                </c:pt>
                <c:pt idx="2">
                  <c:v>LI</c:v>
                </c:pt>
                <c:pt idx="3">
                  <c:v>As</c:v>
                </c:pt>
                <c:pt idx="4">
                  <c:v>Sn</c:v>
                </c:pt>
                <c:pt idx="5">
                  <c:v>Sb</c:v>
                </c:pt>
                <c:pt idx="6">
                  <c:v>Se</c:v>
                </c:pt>
                <c:pt idx="7">
                  <c:v>Cd</c:v>
                </c:pt>
                <c:pt idx="8">
                  <c:v>Be</c:v>
                </c:pt>
                <c:pt idx="9">
                  <c:v>Te</c:v>
                </c:pt>
              </c:strCache>
            </c:strRef>
          </c:cat>
          <c:val>
            <c:numRef>
              <c:f>'Final table heavy metal'!$B$27:$B$36</c:f>
              <c:numCache>
                <c:formatCode>0.000</c:formatCode>
                <c:ptCount val="10"/>
                <c:pt idx="0">
                  <c:v>0.13033333333333333</c:v>
                </c:pt>
                <c:pt idx="1">
                  <c:v>0.12116666666666666</c:v>
                </c:pt>
                <c:pt idx="2">
                  <c:v>0.11616666666666668</c:v>
                </c:pt>
                <c:pt idx="3">
                  <c:v>9.633333333333334E-2</c:v>
                </c:pt>
                <c:pt idx="4">
                  <c:v>5.3333333333333323E-2</c:v>
                </c:pt>
                <c:pt idx="5">
                  <c:v>4.5333333333333337E-2</c:v>
                </c:pt>
                <c:pt idx="6">
                  <c:v>3.1333333333333331E-2</c:v>
                </c:pt>
                <c:pt idx="7">
                  <c:v>2.2833333333333334E-2</c:v>
                </c:pt>
                <c:pt idx="8">
                  <c:v>4.1666666666666666E-3</c:v>
                </c:pt>
                <c:pt idx="9">
                  <c:v>8.3333333333333339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2AD-4F06-880B-38F063B31657}"/>
            </c:ext>
          </c:extLst>
        </c:ser>
        <c:ser>
          <c:idx val="1"/>
          <c:order val="1"/>
          <c:tx>
            <c:strRef>
              <c:f>'Final table heavy metal'!$C$6</c:f>
              <c:strCache>
                <c:ptCount val="1"/>
                <c:pt idx="0">
                  <c:v>BT infusion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7:$A$36</c:f>
              <c:strCache>
                <c:ptCount val="10"/>
                <c:pt idx="0">
                  <c:v>V</c:v>
                </c:pt>
                <c:pt idx="1">
                  <c:v>Co</c:v>
                </c:pt>
                <c:pt idx="2">
                  <c:v>LI</c:v>
                </c:pt>
                <c:pt idx="3">
                  <c:v>As</c:v>
                </c:pt>
                <c:pt idx="4">
                  <c:v>Sn</c:v>
                </c:pt>
                <c:pt idx="5">
                  <c:v>Sb</c:v>
                </c:pt>
                <c:pt idx="6">
                  <c:v>Se</c:v>
                </c:pt>
                <c:pt idx="7">
                  <c:v>Cd</c:v>
                </c:pt>
                <c:pt idx="8">
                  <c:v>Be</c:v>
                </c:pt>
                <c:pt idx="9">
                  <c:v>Te</c:v>
                </c:pt>
              </c:strCache>
            </c:strRef>
          </c:cat>
          <c:val>
            <c:numRef>
              <c:f>'Final table heavy metal'!$C$27:$C$36</c:f>
              <c:numCache>
                <c:formatCode>0.000</c:formatCode>
                <c:ptCount val="10"/>
                <c:pt idx="0">
                  <c:v>7.8333333333333328E-3</c:v>
                </c:pt>
                <c:pt idx="1">
                  <c:v>4.083333333333334E-2</c:v>
                </c:pt>
                <c:pt idx="2">
                  <c:v>5.0833333333333335E-2</c:v>
                </c:pt>
                <c:pt idx="3">
                  <c:v>3.5333333333333335E-2</c:v>
                </c:pt>
                <c:pt idx="4">
                  <c:v>5.0000000000000001E-3</c:v>
                </c:pt>
                <c:pt idx="5">
                  <c:v>2.166666666666667E-3</c:v>
                </c:pt>
                <c:pt idx="6">
                  <c:v>6.9999999999999993E-3</c:v>
                </c:pt>
                <c:pt idx="7">
                  <c:v>2.8333333333333335E-3</c:v>
                </c:pt>
                <c:pt idx="8">
                  <c:v>2.3333333333333335E-3</c:v>
                </c:pt>
                <c:pt idx="9">
                  <c:v>3.3333333333333332E-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2AD-4F06-880B-38F063B31657}"/>
            </c:ext>
          </c:extLst>
        </c:ser>
        <c:ser>
          <c:idx val="2"/>
          <c:order val="2"/>
          <c:tx>
            <c:strRef>
              <c:f>'Final table heavy metal'!$D$6</c:f>
              <c:strCache>
                <c:ptCount val="1"/>
                <c:pt idx="0">
                  <c:v>OT Leaves </c:v>
                </c:pt>
              </c:strCache>
            </c:strRef>
          </c:tx>
          <c:spPr>
            <a:solidFill>
              <a:srgbClr val="C00000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7:$A$36</c:f>
              <c:strCache>
                <c:ptCount val="10"/>
                <c:pt idx="0">
                  <c:v>V</c:v>
                </c:pt>
                <c:pt idx="1">
                  <c:v>Co</c:v>
                </c:pt>
                <c:pt idx="2">
                  <c:v>LI</c:v>
                </c:pt>
                <c:pt idx="3">
                  <c:v>As</c:v>
                </c:pt>
                <c:pt idx="4">
                  <c:v>Sn</c:v>
                </c:pt>
                <c:pt idx="5">
                  <c:v>Sb</c:v>
                </c:pt>
                <c:pt idx="6">
                  <c:v>Se</c:v>
                </c:pt>
                <c:pt idx="7">
                  <c:v>Cd</c:v>
                </c:pt>
                <c:pt idx="8">
                  <c:v>Be</c:v>
                </c:pt>
                <c:pt idx="9">
                  <c:v>Te</c:v>
                </c:pt>
              </c:strCache>
            </c:strRef>
          </c:cat>
          <c:val>
            <c:numRef>
              <c:f>'Final table heavy metal'!$D$27:$D$36</c:f>
              <c:numCache>
                <c:formatCode>0.000</c:formatCode>
                <c:ptCount val="10"/>
                <c:pt idx="0">
                  <c:v>2.9000000000000001E-2</c:v>
                </c:pt>
                <c:pt idx="1">
                  <c:v>1.7000000000000001E-2</c:v>
                </c:pt>
                <c:pt idx="2">
                  <c:v>7.0000000000000007E-2</c:v>
                </c:pt>
                <c:pt idx="3">
                  <c:v>1.4999999999999999E-2</c:v>
                </c:pt>
                <c:pt idx="4">
                  <c:v>5.2999999999999999E-2</c:v>
                </c:pt>
                <c:pt idx="5">
                  <c:v>1.2E-2</c:v>
                </c:pt>
                <c:pt idx="6">
                  <c:v>2.5000000000000001E-2</c:v>
                </c:pt>
                <c:pt idx="7">
                  <c:v>1.4999999999999999E-2</c:v>
                </c:pt>
                <c:pt idx="8">
                  <c:v>0</c:v>
                </c:pt>
                <c:pt idx="9">
                  <c:v>3.000000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2AD-4F06-880B-38F063B31657}"/>
            </c:ext>
          </c:extLst>
        </c:ser>
        <c:ser>
          <c:idx val="3"/>
          <c:order val="3"/>
          <c:tx>
            <c:strRef>
              <c:f>'Final table heavy metal'!$E$6</c:f>
              <c:strCache>
                <c:ptCount val="1"/>
                <c:pt idx="0">
                  <c:v>OT tea </c:v>
                </c:pt>
              </c:strCache>
            </c:strRef>
          </c:tx>
          <c:spPr>
            <a:solidFill>
              <a:srgbClr val="FF7D7D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7:$A$36</c:f>
              <c:strCache>
                <c:ptCount val="10"/>
                <c:pt idx="0">
                  <c:v>V</c:v>
                </c:pt>
                <c:pt idx="1">
                  <c:v>Co</c:v>
                </c:pt>
                <c:pt idx="2">
                  <c:v>LI</c:v>
                </c:pt>
                <c:pt idx="3">
                  <c:v>As</c:v>
                </c:pt>
                <c:pt idx="4">
                  <c:v>Sn</c:v>
                </c:pt>
                <c:pt idx="5">
                  <c:v>Sb</c:v>
                </c:pt>
                <c:pt idx="6">
                  <c:v>Se</c:v>
                </c:pt>
                <c:pt idx="7">
                  <c:v>Cd</c:v>
                </c:pt>
                <c:pt idx="8">
                  <c:v>Be</c:v>
                </c:pt>
                <c:pt idx="9">
                  <c:v>Te</c:v>
                </c:pt>
              </c:strCache>
            </c:strRef>
          </c:cat>
          <c:val>
            <c:numRef>
              <c:f>'Final table heavy metal'!$E$27:$E$36</c:f>
              <c:numCache>
                <c:formatCode>0.000</c:formatCode>
                <c:ptCount val="10"/>
                <c:pt idx="0">
                  <c:v>1E-3</c:v>
                </c:pt>
                <c:pt idx="1">
                  <c:v>2.5999999999999999E-2</c:v>
                </c:pt>
                <c:pt idx="2">
                  <c:v>7.0999999999999994E-2</c:v>
                </c:pt>
                <c:pt idx="3">
                  <c:v>5.0000000000000001E-3</c:v>
                </c:pt>
                <c:pt idx="4">
                  <c:v>4.0000000000000001E-3</c:v>
                </c:pt>
                <c:pt idx="5">
                  <c:v>0</c:v>
                </c:pt>
                <c:pt idx="6">
                  <c:v>0.01</c:v>
                </c:pt>
                <c:pt idx="7">
                  <c:v>1E-3</c:v>
                </c:pt>
                <c:pt idx="8">
                  <c:v>8.9999999999999993E-3</c:v>
                </c:pt>
                <c:pt idx="9">
                  <c:v>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2AD-4F06-880B-38F063B31657}"/>
            </c:ext>
          </c:extLst>
        </c:ser>
        <c:ser>
          <c:idx val="4"/>
          <c:order val="4"/>
          <c:tx>
            <c:strRef>
              <c:f>'Final table heavy metal'!$F$6</c:f>
              <c:strCache>
                <c:ptCount val="1"/>
                <c:pt idx="0">
                  <c:v>GT Leaves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7:$A$36</c:f>
              <c:strCache>
                <c:ptCount val="10"/>
                <c:pt idx="0">
                  <c:v>V</c:v>
                </c:pt>
                <c:pt idx="1">
                  <c:v>Co</c:v>
                </c:pt>
                <c:pt idx="2">
                  <c:v>LI</c:v>
                </c:pt>
                <c:pt idx="3">
                  <c:v>As</c:v>
                </c:pt>
                <c:pt idx="4">
                  <c:v>Sn</c:v>
                </c:pt>
                <c:pt idx="5">
                  <c:v>Sb</c:v>
                </c:pt>
                <c:pt idx="6">
                  <c:v>Se</c:v>
                </c:pt>
                <c:pt idx="7">
                  <c:v>Cd</c:v>
                </c:pt>
                <c:pt idx="8">
                  <c:v>Be</c:v>
                </c:pt>
                <c:pt idx="9">
                  <c:v>Te</c:v>
                </c:pt>
              </c:strCache>
            </c:strRef>
          </c:cat>
          <c:val>
            <c:numRef>
              <c:f>'Final table heavy metal'!$F$27:$F$36</c:f>
              <c:numCache>
                <c:formatCode>0.000</c:formatCode>
                <c:ptCount val="10"/>
                <c:pt idx="0">
                  <c:v>7.0499999999999993E-2</c:v>
                </c:pt>
                <c:pt idx="1">
                  <c:v>0.21299999999999999</c:v>
                </c:pt>
                <c:pt idx="2">
                  <c:v>0.13900000000000001</c:v>
                </c:pt>
                <c:pt idx="3">
                  <c:v>4.5499999999999999E-2</c:v>
                </c:pt>
                <c:pt idx="4">
                  <c:v>9.0499999999999997E-2</c:v>
                </c:pt>
                <c:pt idx="5">
                  <c:v>3.4500000000000003E-2</c:v>
                </c:pt>
                <c:pt idx="6">
                  <c:v>2.4500000000000001E-2</c:v>
                </c:pt>
                <c:pt idx="7">
                  <c:v>3.4500000000000003E-2</c:v>
                </c:pt>
                <c:pt idx="8">
                  <c:v>2.5000000000000001E-3</c:v>
                </c:pt>
                <c:pt idx="9">
                  <c:v>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2AD-4F06-880B-38F063B31657}"/>
            </c:ext>
          </c:extLst>
        </c:ser>
        <c:ser>
          <c:idx val="5"/>
          <c:order val="5"/>
          <c:tx>
            <c:strRef>
              <c:f>'Final table heavy metal'!$G$6</c:f>
              <c:strCache>
                <c:ptCount val="1"/>
                <c:pt idx="0">
                  <c:v>GT infusion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Final table heavy metal'!$A$27:$A$36</c:f>
              <c:strCache>
                <c:ptCount val="10"/>
                <c:pt idx="0">
                  <c:v>V</c:v>
                </c:pt>
                <c:pt idx="1">
                  <c:v>Co</c:v>
                </c:pt>
                <c:pt idx="2">
                  <c:v>LI</c:v>
                </c:pt>
                <c:pt idx="3">
                  <c:v>As</c:v>
                </c:pt>
                <c:pt idx="4">
                  <c:v>Sn</c:v>
                </c:pt>
                <c:pt idx="5">
                  <c:v>Sb</c:v>
                </c:pt>
                <c:pt idx="6">
                  <c:v>Se</c:v>
                </c:pt>
                <c:pt idx="7">
                  <c:v>Cd</c:v>
                </c:pt>
                <c:pt idx="8">
                  <c:v>Be</c:v>
                </c:pt>
                <c:pt idx="9">
                  <c:v>Te</c:v>
                </c:pt>
              </c:strCache>
            </c:strRef>
          </c:cat>
          <c:val>
            <c:numRef>
              <c:f>'Final table heavy metal'!$G$27:$G$36</c:f>
              <c:numCache>
                <c:formatCode>0.000</c:formatCode>
                <c:ptCount val="10"/>
                <c:pt idx="0">
                  <c:v>1.5E-3</c:v>
                </c:pt>
                <c:pt idx="1">
                  <c:v>0.3725</c:v>
                </c:pt>
                <c:pt idx="2">
                  <c:v>3.4000000000000002E-2</c:v>
                </c:pt>
                <c:pt idx="3">
                  <c:v>2.4500000000000001E-2</c:v>
                </c:pt>
                <c:pt idx="4">
                  <c:v>6.0000000000000001E-3</c:v>
                </c:pt>
                <c:pt idx="5">
                  <c:v>8.0000000000000002E-3</c:v>
                </c:pt>
                <c:pt idx="6">
                  <c:v>7.4999999999999997E-3</c:v>
                </c:pt>
                <c:pt idx="7">
                  <c:v>1.5E-3</c:v>
                </c:pt>
                <c:pt idx="8">
                  <c:v>1E-3</c:v>
                </c:pt>
                <c:pt idx="9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2AD-4F06-880B-38F063B316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48953712"/>
        <c:axId val="-548948816"/>
      </c:barChart>
      <c:catAx>
        <c:axId val="-548953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8948816"/>
        <c:crosses val="autoZero"/>
        <c:auto val="1"/>
        <c:lblAlgn val="ctr"/>
        <c:lblOffset val="100"/>
        <c:noMultiLvlLbl val="0"/>
      </c:catAx>
      <c:valAx>
        <c:axId val="-5489488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it-IT" sz="1400" b="1"/>
                  <a:t>µg/g</a:t>
                </a:r>
              </a:p>
            </c:rich>
          </c:tx>
          <c:layout>
            <c:manualLayout>
              <c:xMode val="edge"/>
              <c:yMode val="edge"/>
              <c:x val="8.7077673284569838E-3"/>
              <c:y val="0.4085702246484365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.00" sourceLinked="0"/>
        <c:majorTickMark val="none"/>
        <c:minorTickMark val="none"/>
        <c:tickLblPos val="nextTo"/>
        <c:spPr>
          <a:noFill/>
          <a:ln w="6350" cap="flat" cmpd="sng" algn="ctr">
            <a:solidFill>
              <a:schemeClr val="dk1"/>
            </a:solidFill>
            <a:prstDash val="solid"/>
            <a:miter lim="800000"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5489537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15C2DB-6F72-44FE-969D-B0FD2C04E0E8}" type="datetimeFigureOut">
              <a:rPr lang="en-US" smtClean="0"/>
              <a:t>6/8/2020</a:t>
            </a:fld>
            <a:endParaRPr lang="en-US" dirty="0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D29D9FE-51C5-4C01-BDAF-FEBBDBC8E404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83681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D29D9FE-51C5-4C01-BDAF-FEBBDBC8E404}" type="slidenum">
              <a:rPr lang="en-US" smtClean="0"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443843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D9F028-7506-4124-90B4-305F03ABFA36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63864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A95464-9AD3-41DB-8D82-7B680ED10C3A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5295456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9ADD05-A8F5-497A-B3D9-FF8BB2AAF6F4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8777047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982166-F10D-48F2-BDD4-03C6F94302D0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64223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4FCEFA-B388-4EE6-8741-5DF0F1AA8491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368639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938510-E8D1-4D4D-AEAA-B2CE42352221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5356789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83C9F9-3B35-4E8D-B8A2-EE9B05B526B6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539127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D6D1F1-A609-4B57-9389-EBFDAE9CBDFF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790911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CA6B0-4B71-4F79-8495-21618F93DB5F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876629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3A26B5-0EC6-4C1C-83B8-04816C1E34A7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07472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749030-145B-4EFF-800D-D36BD1728EEE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1000915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5A9D4-C193-4FD6-841E-8293BBBC77D1}" type="datetime1">
              <a:rPr lang="it-IT" smtClean="0"/>
              <a:t>08/06/2020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B124D9-B409-478C-95D8-B5A0ABA9638E}" type="slidenum">
              <a:rPr lang="it-IT" smtClean="0"/>
              <a:t>‹N›</a:t>
            </a:fld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94396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>
            <a:extLst>
              <a:ext uri="{FF2B5EF4-FFF2-40B4-BE49-F238E27FC236}">
                <a16:creationId xmlns:a16="http://schemas.microsoft.com/office/drawing/2014/main" id="{4DF96296-F4DF-4D5A-B995-46C117BEF75D}"/>
              </a:ext>
            </a:extLst>
          </p:cNvPr>
          <p:cNvSpPr/>
          <p:nvPr/>
        </p:nvSpPr>
        <p:spPr>
          <a:xfrm>
            <a:off x="1155290" y="149833"/>
            <a:ext cx="9881419" cy="65583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US" sz="24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Quantification of polyphenols and metals in Chinese tea infusions by mass spectrometry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briella Pinto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na Illiano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drea Carpentieri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ichele Spinelli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hiara Melchiorre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Carolina Fontanarosa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rtino di Serio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it-IT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ngela Amoresano</a:t>
            </a:r>
            <a:r>
              <a:rPr lang="it-IT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,2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it-IT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ment Chemical Sciences, University of Naples Federico II, Monte S. Angelo - Cinthia, 80126, Naples, Italy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it-IT" baseline="300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2</a:t>
            </a:r>
            <a:r>
              <a:rPr lang="it-IT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tituto Nazionale </a:t>
            </a:r>
            <a:r>
              <a:rPr lang="it-IT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strutture</a:t>
            </a:r>
            <a:r>
              <a:rPr lang="it-IT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 Biosistemi – Consorzio Interuniversitario Viale delle Medaglie d'Oro, 305, 00136 Roma RM. 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it-IT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sponding author: </a:t>
            </a:r>
            <a:r>
              <a:rPr lang="en-GB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na.illiano@unina.it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eywords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tabolites; Polyphenols; Heavy metals; Mass spectrometry; MRM mode; Chinese tea infusion.</a:t>
            </a:r>
            <a:endParaRPr lang="it-IT" sz="16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it-IT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" name="Segnaposto numero diapositiva 2">
            <a:extLst>
              <a:ext uri="{FF2B5EF4-FFF2-40B4-BE49-F238E27FC236}">
                <a16:creationId xmlns:a16="http://schemas.microsoft.com/office/drawing/2014/main" id="{45945C10-645C-4EDA-BA57-F125570C6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B124D9-B409-478C-95D8-B5A0ABA9638E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1061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9B71F685-C023-4A37-8870-6FF49A0A9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750300" y="6457950"/>
            <a:ext cx="2743200" cy="365125"/>
          </a:xfrm>
        </p:spPr>
        <p:txBody>
          <a:bodyPr/>
          <a:lstStyle/>
          <a:p>
            <a:fld id="{B7B124D9-B409-478C-95D8-B5A0ABA9638E}" type="slidenum">
              <a:rPr lang="it-IT" smtClean="0"/>
              <a:t>2</a:t>
            </a:fld>
            <a:endParaRPr lang="it-IT"/>
          </a:p>
        </p:txBody>
      </p:sp>
      <p:graphicFrame>
        <p:nvGraphicFramePr>
          <p:cNvPr id="5" name="Grafico 4">
            <a:extLst>
              <a:ext uri="{FF2B5EF4-FFF2-40B4-BE49-F238E27FC236}">
                <a16:creationId xmlns:a16="http://schemas.microsoft.com/office/drawing/2014/main" id="{36D01608-D2DA-4C58-91ED-477A18E80A4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869010"/>
              </p:ext>
            </p:extLst>
          </p:nvPr>
        </p:nvGraphicFramePr>
        <p:xfrm>
          <a:off x="698500" y="819725"/>
          <a:ext cx="10883900" cy="60770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5F1F8FB9-35EE-4B05-AB76-2EE20ED7272D}"/>
              </a:ext>
            </a:extLst>
          </p:cNvPr>
          <p:cNvSpPr txBox="1"/>
          <p:nvPr/>
        </p:nvSpPr>
        <p:spPr>
          <a:xfrm>
            <a:off x="374650" y="34925"/>
            <a:ext cx="11531600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grams</a:t>
            </a:r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lavonoid</a:t>
            </a:r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ycosides</a:t>
            </a:r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</a:t>
            </a:r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ea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usions</a:t>
            </a:r>
            <a:endParaRPr lang="it-IT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55044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Grafico 12">
            <a:extLst>
              <a:ext uri="{FF2B5EF4-FFF2-40B4-BE49-F238E27FC236}">
                <a16:creationId xmlns:a16="http://schemas.microsoft.com/office/drawing/2014/main" id="{0EF05760-4D82-41FD-BF79-25407F6E015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7436542"/>
              </p:ext>
            </p:extLst>
          </p:nvPr>
        </p:nvGraphicFramePr>
        <p:xfrm>
          <a:off x="5892800" y="616593"/>
          <a:ext cx="6006360" cy="53322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8" name="Grafico 17">
            <a:extLst>
              <a:ext uri="{FF2B5EF4-FFF2-40B4-BE49-F238E27FC236}">
                <a16:creationId xmlns:a16="http://schemas.microsoft.com/office/drawing/2014/main" id="{00000000-0008-0000-00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5197634"/>
              </p:ext>
            </p:extLst>
          </p:nvPr>
        </p:nvGraphicFramePr>
        <p:xfrm>
          <a:off x="292840" y="660973"/>
          <a:ext cx="6006361" cy="50793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F2FA4922-0A7C-48ED-9D0E-6966CE9416D9}"/>
              </a:ext>
            </a:extLst>
          </p:cNvPr>
          <p:cNvSpPr txBox="1"/>
          <p:nvPr/>
        </p:nvSpPr>
        <p:spPr>
          <a:xfrm>
            <a:off x="92177" y="76198"/>
            <a:ext cx="12007645" cy="58477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grams</a:t>
            </a:r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trace metals in tea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ves</a:t>
            </a:r>
            <a:r>
              <a:rPr lang="it-IT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it-IT" sz="3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usions</a:t>
            </a:r>
            <a:endParaRPr lang="it-IT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uppo 5">
            <a:extLst>
              <a:ext uri="{FF2B5EF4-FFF2-40B4-BE49-F238E27FC236}">
                <a16:creationId xmlns:a16="http://schemas.microsoft.com/office/drawing/2014/main" id="{10058146-876F-4D87-98E4-552704D956E8}"/>
              </a:ext>
            </a:extLst>
          </p:cNvPr>
          <p:cNvGrpSpPr/>
          <p:nvPr/>
        </p:nvGrpSpPr>
        <p:grpSpPr>
          <a:xfrm>
            <a:off x="2828823" y="5726106"/>
            <a:ext cx="7476556" cy="989725"/>
            <a:chOff x="7048500" y="1965921"/>
            <a:chExt cx="7476556" cy="989725"/>
          </a:xfrm>
        </p:grpSpPr>
        <p:sp>
          <p:nvSpPr>
            <p:cNvPr id="7" name="Rettangolo 6">
              <a:extLst>
                <a:ext uri="{FF2B5EF4-FFF2-40B4-BE49-F238E27FC236}">
                  <a16:creationId xmlns:a16="http://schemas.microsoft.com/office/drawing/2014/main" id="{49DB4408-AE89-4177-AA8B-435B2C21FFD9}"/>
                </a:ext>
              </a:extLst>
            </p:cNvPr>
            <p:cNvSpPr/>
            <p:nvPr/>
          </p:nvSpPr>
          <p:spPr>
            <a:xfrm>
              <a:off x="7048500" y="2654300"/>
              <a:ext cx="144000" cy="144000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8" name="Rettangolo 7">
              <a:extLst>
                <a:ext uri="{FF2B5EF4-FFF2-40B4-BE49-F238E27FC236}">
                  <a16:creationId xmlns:a16="http://schemas.microsoft.com/office/drawing/2014/main" id="{F7877356-50B6-495C-BE86-69912F45597D}"/>
                </a:ext>
              </a:extLst>
            </p:cNvPr>
            <p:cNvSpPr/>
            <p:nvPr/>
          </p:nvSpPr>
          <p:spPr>
            <a:xfrm>
              <a:off x="7048500" y="2145969"/>
              <a:ext cx="144000" cy="144000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ttangolo 8">
              <a:extLst>
                <a:ext uri="{FF2B5EF4-FFF2-40B4-BE49-F238E27FC236}">
                  <a16:creationId xmlns:a16="http://schemas.microsoft.com/office/drawing/2014/main" id="{B3365190-5F38-45BB-BCCC-7CCEEF1C3CC9}"/>
                </a:ext>
              </a:extLst>
            </p:cNvPr>
            <p:cNvSpPr/>
            <p:nvPr/>
          </p:nvSpPr>
          <p:spPr>
            <a:xfrm>
              <a:off x="10061499" y="2103193"/>
              <a:ext cx="144000" cy="144000"/>
            </a:xfrm>
            <a:prstGeom prst="rect">
              <a:avLst/>
            </a:prstGeom>
            <a:solidFill>
              <a:srgbClr val="C0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0" name="Rettangolo 9">
              <a:extLst>
                <a:ext uri="{FF2B5EF4-FFF2-40B4-BE49-F238E27FC236}">
                  <a16:creationId xmlns:a16="http://schemas.microsoft.com/office/drawing/2014/main" id="{E9C91AFE-5436-464F-BEDD-7330893445DE}"/>
                </a:ext>
              </a:extLst>
            </p:cNvPr>
            <p:cNvSpPr/>
            <p:nvPr/>
          </p:nvSpPr>
          <p:spPr>
            <a:xfrm>
              <a:off x="10048799" y="2643371"/>
              <a:ext cx="144000" cy="144000"/>
            </a:xfrm>
            <a:prstGeom prst="rect">
              <a:avLst/>
            </a:prstGeom>
            <a:solidFill>
              <a:srgbClr val="FF7D7D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1" name="Rettangolo 10">
              <a:extLst>
                <a:ext uri="{FF2B5EF4-FFF2-40B4-BE49-F238E27FC236}">
                  <a16:creationId xmlns:a16="http://schemas.microsoft.com/office/drawing/2014/main" id="{EA523D1A-6385-40AD-A131-948440C2B997}"/>
                </a:ext>
              </a:extLst>
            </p:cNvPr>
            <p:cNvSpPr/>
            <p:nvPr/>
          </p:nvSpPr>
          <p:spPr>
            <a:xfrm>
              <a:off x="12745819" y="2165976"/>
              <a:ext cx="144000" cy="144000"/>
            </a:xfrm>
            <a:prstGeom prst="rect">
              <a:avLst/>
            </a:prstGeom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2" name="Rettangolo 11">
              <a:extLst>
                <a:ext uri="{FF2B5EF4-FFF2-40B4-BE49-F238E27FC236}">
                  <a16:creationId xmlns:a16="http://schemas.microsoft.com/office/drawing/2014/main" id="{4BC94A39-7C10-44A8-B88A-6A16C2A4676B}"/>
                </a:ext>
              </a:extLst>
            </p:cNvPr>
            <p:cNvSpPr/>
            <p:nvPr/>
          </p:nvSpPr>
          <p:spPr>
            <a:xfrm>
              <a:off x="12745819" y="2699376"/>
              <a:ext cx="144000" cy="1440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2000"/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450C9703-1154-4A89-9931-9EC459D5C032}"/>
                </a:ext>
              </a:extLst>
            </p:cNvPr>
            <p:cNvSpPr txBox="1"/>
            <p:nvPr/>
          </p:nvSpPr>
          <p:spPr>
            <a:xfrm>
              <a:off x="7251197" y="2033303"/>
              <a:ext cx="124123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 leaves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931F8FA0-7A80-4171-948D-E3AE2C242ACC}"/>
                </a:ext>
              </a:extLst>
            </p:cNvPr>
            <p:cNvSpPr txBox="1"/>
            <p:nvPr/>
          </p:nvSpPr>
          <p:spPr>
            <a:xfrm>
              <a:off x="7257547" y="2516366"/>
              <a:ext cx="146886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 infusion</a:t>
              </a:r>
            </a:p>
          </p:txBody>
        </p:sp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3F46E087-EFB1-45EA-B95D-BBD973829B54}"/>
                </a:ext>
              </a:extLst>
            </p:cNvPr>
            <p:cNvSpPr txBox="1"/>
            <p:nvPr/>
          </p:nvSpPr>
          <p:spPr>
            <a:xfrm>
              <a:off x="10264196" y="1965921"/>
              <a:ext cx="123168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 leaves</a:t>
              </a:r>
            </a:p>
          </p:txBody>
        </p:sp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0734B86C-254E-437D-B093-329AB589C4B2}"/>
                </a:ext>
              </a:extLst>
            </p:cNvPr>
            <p:cNvSpPr txBox="1"/>
            <p:nvPr/>
          </p:nvSpPr>
          <p:spPr>
            <a:xfrm>
              <a:off x="10338271" y="2555536"/>
              <a:ext cx="145931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L infusion</a:t>
              </a:r>
            </a:p>
          </p:txBody>
        </p:sp>
        <p:sp>
          <p:nvSpPr>
            <p:cNvPr id="21" name="CasellaDiTesto 20">
              <a:extLst>
                <a:ext uri="{FF2B5EF4-FFF2-40B4-BE49-F238E27FC236}">
                  <a16:creationId xmlns:a16="http://schemas.microsoft.com/office/drawing/2014/main" id="{B2D7E5E1-BFCF-4FE9-A3AE-ADA495C6AAF1}"/>
                </a:ext>
              </a:extLst>
            </p:cNvPr>
            <p:cNvSpPr txBox="1"/>
            <p:nvPr/>
          </p:nvSpPr>
          <p:spPr>
            <a:xfrm>
              <a:off x="13022591" y="2036873"/>
              <a:ext cx="12684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T leaves</a:t>
              </a:r>
            </a:p>
          </p:txBody>
        </p:sp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DCE419B1-3112-4B49-B871-AF691AD84601}"/>
                </a:ext>
              </a:extLst>
            </p:cNvPr>
            <p:cNvSpPr txBox="1"/>
            <p:nvPr/>
          </p:nvSpPr>
          <p:spPr>
            <a:xfrm>
              <a:off x="13028941" y="2545336"/>
              <a:ext cx="1496115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T infusio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6473380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90</TotalTime>
  <Words>83</Words>
  <Application>Microsoft Office PowerPoint</Application>
  <PresentationFormat>Widescreen</PresentationFormat>
  <Paragraphs>25</Paragraphs>
  <Slides>3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abriella Pinto</dc:creator>
  <cp:lastModifiedBy>Gabriella Pinto</cp:lastModifiedBy>
  <cp:revision>130</cp:revision>
  <cp:lastPrinted>2019-01-22T10:47:56Z</cp:lastPrinted>
  <dcterms:created xsi:type="dcterms:W3CDTF">2019-01-19T15:28:57Z</dcterms:created>
  <dcterms:modified xsi:type="dcterms:W3CDTF">2020-06-08T08:34:57Z</dcterms:modified>
</cp:coreProperties>
</file>